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59" r:id="rId4"/>
    <p:sldId id="258" r:id="rId5"/>
    <p:sldId id="25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36" autoAdjust="0"/>
    <p:restoredTop sz="94660"/>
  </p:normalViewPr>
  <p:slideViewPr>
    <p:cSldViewPr snapToGrid="0">
      <p:cViewPr varScale="1">
        <p:scale>
          <a:sx n="84" d="100"/>
          <a:sy n="84" d="100"/>
        </p:scale>
        <p:origin x="691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1656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5242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6689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261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09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626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9713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504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329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286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2031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99F81-2892-4FE0-9AB4-B3CF280BE1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E9DF8-1136-4321-8A32-DBBC969F56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614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7038" y="-1523978"/>
            <a:ext cx="6021818" cy="8280000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ED74972-D381-4704-9E3D-EC1A2813EFAF}"/>
              </a:ext>
            </a:extLst>
          </p:cNvPr>
          <p:cNvSpPr txBox="1">
            <a:spLocks/>
          </p:cNvSpPr>
          <p:nvPr/>
        </p:nvSpPr>
        <p:spPr>
          <a:xfrm>
            <a:off x="156830" y="124272"/>
            <a:ext cx="3988587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hospho-CDK1-T14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982438" y="3974321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5235820" y="4217574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5142991" y="3916838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482206" y="4150012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5854996" y="4088854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5194818" y="3501908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7917227" y="426670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120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/>
          <p:cNvGrpSpPr/>
          <p:nvPr/>
        </p:nvGrpSpPr>
        <p:grpSpPr>
          <a:xfrm>
            <a:off x="3911482" y="3597024"/>
            <a:ext cx="585417" cy="276999"/>
            <a:chOff x="-4007534" y="10215563"/>
            <a:chExt cx="585417" cy="276999"/>
          </a:xfrm>
        </p:grpSpPr>
        <p:sp>
          <p:nvSpPr>
            <p:cNvPr id="40" name="矩形 39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组合 41"/>
          <p:cNvGrpSpPr/>
          <p:nvPr/>
        </p:nvGrpSpPr>
        <p:grpSpPr>
          <a:xfrm>
            <a:off x="3911468" y="3996129"/>
            <a:ext cx="585417" cy="276999"/>
            <a:chOff x="-4007534" y="10215563"/>
            <a:chExt cx="585417" cy="276999"/>
          </a:xfrm>
        </p:grpSpPr>
        <p:sp>
          <p:nvSpPr>
            <p:cNvPr id="43" name="矩形 42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11420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6400" y="-2525265"/>
            <a:ext cx="6021818" cy="8280000"/>
          </a:xfrm>
          <a:prstGeom prst="rect">
            <a:avLst/>
          </a:prstGeom>
        </p:spPr>
      </p:pic>
      <p:sp>
        <p:nvSpPr>
          <p:cNvPr id="50" name="标题 1">
            <a:extLst>
              <a:ext uri="{FF2B5EF4-FFF2-40B4-BE49-F238E27FC236}">
                <a16:creationId xmlns:a16="http://schemas.microsoft.com/office/drawing/2014/main" xmlns="" id="{8BE8D7B4-40EE-4F44-82D6-FB4C94865686}"/>
              </a:ext>
            </a:extLst>
          </p:cNvPr>
          <p:cNvSpPr txBox="1">
            <a:spLocks/>
          </p:cNvSpPr>
          <p:nvPr/>
        </p:nvSpPr>
        <p:spPr>
          <a:xfrm>
            <a:off x="533400" y="94704"/>
            <a:ext cx="2294121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DK1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2993981" y="4192036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247363" y="4435289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154534" y="4134553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93749" y="4367727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866539" y="4306569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3206361" y="3719623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5928770" y="448442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145.5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1943262" y="3627646"/>
            <a:ext cx="585417" cy="276999"/>
            <a:chOff x="-4007534" y="10215563"/>
            <a:chExt cx="585417" cy="276999"/>
          </a:xfrm>
        </p:grpSpPr>
        <p:sp>
          <p:nvSpPr>
            <p:cNvPr id="38" name="矩形 37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接连接符 38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/>
          <p:cNvGrpSpPr/>
          <p:nvPr/>
        </p:nvGrpSpPr>
        <p:grpSpPr>
          <a:xfrm>
            <a:off x="1943248" y="4026751"/>
            <a:ext cx="585417" cy="276999"/>
            <a:chOff x="-4007534" y="10215563"/>
            <a:chExt cx="585417" cy="276999"/>
          </a:xfrm>
        </p:grpSpPr>
        <p:sp>
          <p:nvSpPr>
            <p:cNvPr id="41" name="矩形 40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/>
          <p:cNvGrpSpPr/>
          <p:nvPr/>
        </p:nvGrpSpPr>
        <p:grpSpPr>
          <a:xfrm>
            <a:off x="1943248" y="3350994"/>
            <a:ext cx="585417" cy="276999"/>
            <a:chOff x="-4007534" y="10215563"/>
            <a:chExt cx="585417" cy="276999"/>
          </a:xfrm>
        </p:grpSpPr>
        <p:sp>
          <p:nvSpPr>
            <p:cNvPr id="44" name="矩形 4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257353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1963" y="-2701301"/>
            <a:ext cx="6021818" cy="8280000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ED2871F-E1FF-49FE-B421-8F07D564E8A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174455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3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2A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90386" y="4442958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743768" y="4686211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650939" y="4385475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990154" y="4618649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362944" y="4557491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702766" y="3950225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2986434" y="3629743"/>
            <a:ext cx="585417" cy="276999"/>
            <a:chOff x="-4007534" y="10215563"/>
            <a:chExt cx="585417" cy="276999"/>
          </a:xfrm>
        </p:grpSpPr>
        <p:sp>
          <p:nvSpPr>
            <p:cNvPr id="43" name="矩形 42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" name="组合 44"/>
          <p:cNvGrpSpPr/>
          <p:nvPr/>
        </p:nvGrpSpPr>
        <p:grpSpPr>
          <a:xfrm>
            <a:off x="2986420" y="4270148"/>
            <a:ext cx="585417" cy="276999"/>
            <a:chOff x="-4007534" y="10215563"/>
            <a:chExt cx="585417" cy="276999"/>
          </a:xfrm>
        </p:grpSpPr>
        <p:sp>
          <p:nvSpPr>
            <p:cNvPr id="46" name="矩形 45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连接符 4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8" name="矩形 47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202872" y="4331723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780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7614" y="-2345132"/>
            <a:ext cx="6021818" cy="8280000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C2502D-7B2E-4F08-B5EE-2805D9896CB1}"/>
              </a:ext>
            </a:extLst>
          </p:cNvPr>
          <p:cNvSpPr txBox="1">
            <a:spLocks/>
          </p:cNvSpPr>
          <p:nvPr/>
        </p:nvSpPr>
        <p:spPr>
          <a:xfrm>
            <a:off x="552450" y="319991"/>
            <a:ext cx="850913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3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490387" y="4036558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743769" y="4279811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650940" y="3979075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990155" y="4212249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362945" y="4151091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702767" y="3543825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2986435" y="3223343"/>
            <a:ext cx="585417" cy="276999"/>
            <a:chOff x="-4007534" y="10215563"/>
            <a:chExt cx="585417" cy="276999"/>
          </a:xfrm>
        </p:grpSpPr>
        <p:sp>
          <p:nvSpPr>
            <p:cNvPr id="43" name="矩形 42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" name="组合 44"/>
          <p:cNvGrpSpPr/>
          <p:nvPr/>
        </p:nvGrpSpPr>
        <p:grpSpPr>
          <a:xfrm>
            <a:off x="2986421" y="3863748"/>
            <a:ext cx="585417" cy="276999"/>
            <a:chOff x="-4007534" y="10215563"/>
            <a:chExt cx="585417" cy="276999"/>
          </a:xfrm>
        </p:grpSpPr>
        <p:sp>
          <p:nvSpPr>
            <p:cNvPr id="46" name="矩形 45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连接符 4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8" name="矩形 47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6202873" y="3925323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2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6736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3666" y="-2584051"/>
            <a:ext cx="6021818" cy="8280000"/>
          </a:xfrm>
          <a:prstGeom prst="rect">
            <a:avLst/>
          </a:prstGeom>
        </p:spPr>
      </p:pic>
      <p:sp>
        <p:nvSpPr>
          <p:cNvPr id="29" name="标题 1">
            <a:extLst>
              <a:ext uri="{FF2B5EF4-FFF2-40B4-BE49-F238E27FC236}">
                <a16:creationId xmlns:a16="http://schemas.microsoft.com/office/drawing/2014/main" xmlns="" id="{5EBBC431-FBC1-4527-BC36-D307E5F9B122}"/>
              </a:ext>
            </a:extLst>
          </p:cNvPr>
          <p:cNvSpPr txBox="1">
            <a:spLocks/>
          </p:cNvSpPr>
          <p:nvPr/>
        </p:nvSpPr>
        <p:spPr>
          <a:xfrm>
            <a:off x="533400" y="94704"/>
            <a:ext cx="1763600" cy="577970"/>
          </a:xfrm>
          <a:prstGeom prst="rect">
            <a:avLst/>
          </a:prstGeom>
        </p:spPr>
        <p:txBody>
          <a:bodyPr>
            <a:normAutofit lnSpcReduction="10000"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altLang="zh-CN" sz="32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GAPDH</a:t>
            </a:r>
            <a:endParaRPr lang="zh-CN" altLang="en-US" sz="32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257116" y="3917518"/>
            <a:ext cx="10977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xmlns="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3510498" y="4160771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E1DB421E-9ACF-464C-8ACB-D1AB43B55ABB}"/>
              </a:ext>
            </a:extLst>
          </p:cNvPr>
          <p:cNvSpPr/>
          <p:nvPr/>
        </p:nvSpPr>
        <p:spPr>
          <a:xfrm>
            <a:off x="3429281" y="3860035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AC-CN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3756884" y="4093209"/>
            <a:ext cx="7225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xmlns="" id="{7ED4BE5C-CEFD-4FEE-B154-600181E1D326}"/>
              </a:ext>
            </a:extLst>
          </p:cNvPr>
          <p:cNvSpPr/>
          <p:nvPr/>
        </p:nvSpPr>
        <p:spPr>
          <a:xfrm rot="17430996">
            <a:off x="4129674" y="4032051"/>
            <a:ext cx="8531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3506072" y="3333345"/>
            <a:ext cx="1321921" cy="445628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组合 42"/>
          <p:cNvGrpSpPr/>
          <p:nvPr/>
        </p:nvGrpSpPr>
        <p:grpSpPr>
          <a:xfrm>
            <a:off x="2753164" y="3428390"/>
            <a:ext cx="585417" cy="276999"/>
            <a:chOff x="-4007534" y="10215563"/>
            <a:chExt cx="585417" cy="276999"/>
          </a:xfrm>
        </p:grpSpPr>
        <p:sp>
          <p:nvSpPr>
            <p:cNvPr id="44" name="矩形 43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/>
          <p:cNvGrpSpPr/>
          <p:nvPr/>
        </p:nvGrpSpPr>
        <p:grpSpPr>
          <a:xfrm>
            <a:off x="2753150" y="4022500"/>
            <a:ext cx="585417" cy="276999"/>
            <a:chOff x="-4007534" y="10215563"/>
            <a:chExt cx="585417" cy="276999"/>
          </a:xfrm>
        </p:grpSpPr>
        <p:sp>
          <p:nvSpPr>
            <p:cNvPr id="47" name="矩形 46"/>
            <p:cNvSpPr/>
            <p:nvPr/>
          </p:nvSpPr>
          <p:spPr>
            <a:xfrm>
              <a:off x="-4007534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接连接符 47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9" name="矩形 48">
            <a:extLst>
              <a:ext uri="{FF2B5EF4-FFF2-40B4-BE49-F238E27FC236}">
                <a16:creationId xmlns:a16="http://schemas.microsoft.com/office/drawing/2014/main" xmlns="" id="{04F2603A-4C99-4014-9048-120CB6C8E32E}"/>
              </a:ext>
            </a:extLst>
          </p:cNvPr>
          <p:cNvSpPr/>
          <p:nvPr/>
        </p:nvSpPr>
        <p:spPr>
          <a:xfrm flipH="1">
            <a:off x="5128340" y="3832672"/>
            <a:ext cx="863268" cy="379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867" dirty="0" err="1" smtClean="0">
                <a:latin typeface="Arial" panose="020B0604020202020204" pitchFamily="34" charset="0"/>
                <a:cs typeface="Arial" panose="020B0604020202020204" pitchFamily="34" charset="0"/>
              </a:rPr>
              <a:t>0.3s</a:t>
            </a:r>
            <a:endParaRPr lang="zh-CN" altLang="en-US" sz="186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6904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52</Words>
  <Application>Microsoft Office PowerPoint</Application>
  <PresentationFormat>宽屏</PresentationFormat>
  <Paragraphs>4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Yuexiang Wang</cp:lastModifiedBy>
  <cp:revision>7</cp:revision>
  <dcterms:created xsi:type="dcterms:W3CDTF">2024-03-14T03:40:10Z</dcterms:created>
  <dcterms:modified xsi:type="dcterms:W3CDTF">2024-03-14T05:03:53Z</dcterms:modified>
</cp:coreProperties>
</file>